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601575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988" autoAdjust="0"/>
  </p:normalViewPr>
  <p:slideViewPr>
    <p:cSldViewPr>
      <p:cViewPr>
        <p:scale>
          <a:sx n="68" d="100"/>
          <a:sy n="68" d="100"/>
        </p:scale>
        <p:origin x="-486" y="-720"/>
      </p:cViewPr>
      <p:guideLst>
        <p:guide orient="horz" pos="2160"/>
        <p:guide pos="396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5118" y="2130426"/>
            <a:ext cx="10711339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90236" y="3886200"/>
            <a:ext cx="8821103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36142" y="274639"/>
            <a:ext cx="2835354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30079" y="274639"/>
            <a:ext cx="8296037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5437" y="4406901"/>
            <a:ext cx="10711339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5437" y="2906713"/>
            <a:ext cx="10711339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0079" y="1600201"/>
            <a:ext cx="556569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05800" y="1600201"/>
            <a:ext cx="556569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0079" y="1535113"/>
            <a:ext cx="556788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0079" y="2174875"/>
            <a:ext cx="556788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01426" y="1535113"/>
            <a:ext cx="557007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01426" y="2174875"/>
            <a:ext cx="557007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080" y="273050"/>
            <a:ext cx="4145831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26866" y="273051"/>
            <a:ext cx="70446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080" y="1435101"/>
            <a:ext cx="4145831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69997" y="4800600"/>
            <a:ext cx="7560945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469997" y="612775"/>
            <a:ext cx="7560945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69997" y="5367338"/>
            <a:ext cx="7560945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0079" y="274638"/>
            <a:ext cx="11341418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0079" y="1600201"/>
            <a:ext cx="11341418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30079" y="6356351"/>
            <a:ext cx="29403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05538" y="6356351"/>
            <a:ext cx="39904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31129" y="6356351"/>
            <a:ext cx="29403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4787" y="304800"/>
            <a:ext cx="12192000" cy="6144399"/>
            <a:chOff x="204787" y="304800"/>
            <a:chExt cx="12192000" cy="614439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68" t="16950" r="57749" b="5397"/>
            <a:stretch/>
          </p:blipFill>
          <p:spPr bwMode="auto">
            <a:xfrm>
              <a:off x="204787" y="457200"/>
              <a:ext cx="817418" cy="56803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11" t="16666" r="58046" b="5683"/>
            <a:stretch/>
          </p:blipFill>
          <p:spPr bwMode="auto">
            <a:xfrm>
              <a:off x="1500187" y="457200"/>
              <a:ext cx="734291" cy="56803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572" r="57963" b="5587"/>
            <a:stretch/>
          </p:blipFill>
          <p:spPr bwMode="auto">
            <a:xfrm>
              <a:off x="3952442" y="311727"/>
              <a:ext cx="748145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761" r="58069" b="5398"/>
            <a:stretch/>
          </p:blipFill>
          <p:spPr bwMode="auto">
            <a:xfrm>
              <a:off x="2670896" y="304800"/>
              <a:ext cx="734291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572" r="57963" b="5587"/>
            <a:stretch/>
          </p:blipFill>
          <p:spPr bwMode="auto">
            <a:xfrm>
              <a:off x="5247842" y="304800"/>
              <a:ext cx="748145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572" r="57963" b="5587"/>
            <a:stretch/>
          </p:blipFill>
          <p:spPr bwMode="auto">
            <a:xfrm>
              <a:off x="6467042" y="304800"/>
              <a:ext cx="748145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80" t="16573" r="56685" b="5397"/>
            <a:stretch/>
          </p:blipFill>
          <p:spPr bwMode="auto">
            <a:xfrm>
              <a:off x="7565447" y="304800"/>
              <a:ext cx="1097540" cy="5708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572" r="57963" b="5587"/>
            <a:stretch/>
          </p:blipFill>
          <p:spPr bwMode="auto">
            <a:xfrm>
              <a:off x="9057842" y="304800"/>
              <a:ext cx="748145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572" r="57963" b="5587"/>
            <a:stretch/>
          </p:blipFill>
          <p:spPr bwMode="auto">
            <a:xfrm>
              <a:off x="10200842" y="325582"/>
              <a:ext cx="748145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87" t="16572" r="57963" b="5587"/>
            <a:stretch/>
          </p:blipFill>
          <p:spPr bwMode="auto">
            <a:xfrm>
              <a:off x="11267642" y="325582"/>
              <a:ext cx="748145" cy="56942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>
              <a:off x="204787" y="6172200"/>
              <a:ext cx="7753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barthi</a:t>
              </a:r>
              <a:endParaRPr lang="en-IN" sz="1200" b="1" i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42987" y="6172200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brachyantha</a:t>
              </a:r>
              <a:endParaRPr lang="en-IN" sz="1200" b="1" i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76487" y="6172200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glaberrima</a:t>
              </a:r>
              <a:endParaRPr lang="en-IN" sz="1200" b="1" i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95687" y="6172200"/>
              <a:ext cx="12573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glumaepatula</a:t>
              </a:r>
              <a:endParaRPr lang="en-IN" sz="1200" b="1" i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967287" y="6172200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meridionalis</a:t>
              </a:r>
              <a:endParaRPr lang="en-IN" sz="1200" b="1" i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415087" y="6172200"/>
              <a:ext cx="800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nivara</a:t>
              </a:r>
              <a:endParaRPr lang="en-IN" sz="1200" b="1" i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634287" y="6172200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punctata</a:t>
              </a:r>
              <a:endParaRPr lang="en-IN" sz="1200" b="1" i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8756507" y="6172200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rufipogon</a:t>
              </a:r>
              <a:endParaRPr lang="en-IN" sz="1200" b="1" i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882186" y="6172200"/>
              <a:ext cx="1295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err="1" smtClean="0"/>
                <a:t>O.Sativa</a:t>
              </a:r>
              <a:r>
                <a:rPr lang="en-US" sz="1200" b="1" i="1" dirty="0" smtClean="0"/>
                <a:t> (</a:t>
              </a:r>
              <a:r>
                <a:rPr lang="en-US" sz="1200" b="1" i="1" dirty="0" err="1" smtClean="0"/>
                <a:t>indica</a:t>
              </a:r>
              <a:r>
                <a:rPr lang="en-US" sz="1200" b="1" i="1" dirty="0" smtClean="0"/>
                <a:t>)</a:t>
              </a:r>
              <a:endParaRPr lang="en-IN" sz="1200" b="1" i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1063287" y="6172200"/>
              <a:ext cx="1333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longistaminata</a:t>
              </a:r>
              <a:endParaRPr lang="en-IN" sz="1200" b="1" i="1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2015827" y="0"/>
            <a:ext cx="585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A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717124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2387" y="117337"/>
            <a:ext cx="12510655" cy="6207263"/>
            <a:chOff x="52387" y="117337"/>
            <a:chExt cx="12510655" cy="6207263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55" t="16382" r="57537" b="5587"/>
            <a:stretch/>
          </p:blipFill>
          <p:spPr bwMode="auto">
            <a:xfrm>
              <a:off x="128587" y="228600"/>
              <a:ext cx="872836" cy="57080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00" t="16573" r="58282" b="5397"/>
            <a:stretch/>
          </p:blipFill>
          <p:spPr bwMode="auto">
            <a:xfrm>
              <a:off x="1347787" y="304800"/>
              <a:ext cx="678874" cy="5708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55" t="16382" r="57537" b="5587"/>
            <a:stretch/>
          </p:blipFill>
          <p:spPr bwMode="auto">
            <a:xfrm>
              <a:off x="2490787" y="228600"/>
              <a:ext cx="872836" cy="57080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61" t="16383" r="57537" b="5398"/>
            <a:stretch/>
          </p:blipFill>
          <p:spPr bwMode="auto">
            <a:xfrm>
              <a:off x="3786187" y="228600"/>
              <a:ext cx="858981" cy="57219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09" t="16573" r="56685" b="5397"/>
            <a:stretch/>
          </p:blipFill>
          <p:spPr bwMode="auto">
            <a:xfrm>
              <a:off x="4929187" y="228600"/>
              <a:ext cx="1080655" cy="5708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7" name="Picture 19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97" t="16587" r="58205" b="5514"/>
            <a:stretch/>
          </p:blipFill>
          <p:spPr bwMode="auto">
            <a:xfrm>
              <a:off x="6453187" y="202946"/>
              <a:ext cx="689318" cy="56984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3" name="Picture 5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334" t="16394" r="56043" b="5338"/>
            <a:stretch/>
          </p:blipFill>
          <p:spPr bwMode="auto">
            <a:xfrm>
              <a:off x="7519987" y="180536"/>
              <a:ext cx="1252024" cy="57255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" name="Picture 19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97" t="16587" r="58205" b="5514"/>
            <a:stretch/>
          </p:blipFill>
          <p:spPr bwMode="auto">
            <a:xfrm>
              <a:off x="9120187" y="152400"/>
              <a:ext cx="689318" cy="56984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" name="Picture 6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61" t="16383" r="57537" b="5398"/>
            <a:stretch/>
          </p:blipFill>
          <p:spPr bwMode="auto">
            <a:xfrm>
              <a:off x="10415587" y="117337"/>
              <a:ext cx="858981" cy="57219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09" t="16573" r="56685" b="5397"/>
            <a:stretch/>
          </p:blipFill>
          <p:spPr bwMode="auto">
            <a:xfrm>
              <a:off x="11482387" y="118404"/>
              <a:ext cx="1080655" cy="5708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52387" y="6047601"/>
              <a:ext cx="7753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barthi</a:t>
              </a:r>
              <a:endParaRPr lang="en-IN" sz="1200" b="1" i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90587" y="6047601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brachyantha</a:t>
              </a:r>
              <a:endParaRPr lang="en-IN" sz="1200" b="1" i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147887" y="6047601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glaberrima</a:t>
              </a:r>
              <a:endParaRPr lang="en-IN" sz="1200" b="1" i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90887" y="6047601"/>
              <a:ext cx="12573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glumaepatula</a:t>
              </a:r>
              <a:endParaRPr lang="en-IN" sz="1200" b="1" i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405687" y="6047601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meridionalis</a:t>
              </a:r>
              <a:endParaRPr lang="en-IN" sz="1200" b="1" i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891587" y="5999202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nivara</a:t>
              </a:r>
              <a:endParaRPr lang="en-IN" sz="1200" b="1" i="1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0072687" y="5999202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punctata</a:t>
              </a:r>
              <a:endParaRPr lang="en-IN" sz="1200" b="1" i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1215687" y="5999202"/>
              <a:ext cx="1181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rufipogon</a:t>
              </a:r>
              <a:endParaRPr lang="en-IN" sz="1200" b="1" i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586287" y="6047601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err="1" smtClean="0"/>
                <a:t>O.Sativa</a:t>
              </a:r>
              <a:r>
                <a:rPr lang="en-US" sz="1200" b="1" i="1" dirty="0" smtClean="0"/>
                <a:t> (</a:t>
              </a:r>
              <a:r>
                <a:rPr lang="en-US" sz="1200" b="1" i="1" dirty="0" err="1" smtClean="0"/>
                <a:t>indica</a:t>
              </a:r>
              <a:r>
                <a:rPr lang="en-US" sz="1200" b="1" i="1" dirty="0" smtClean="0"/>
                <a:t>)</a:t>
              </a:r>
              <a:endParaRPr lang="en-IN" sz="1200" b="1" i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957887" y="6047601"/>
              <a:ext cx="1333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/>
                <a:t>O. </a:t>
              </a:r>
              <a:r>
                <a:rPr lang="en-US" sz="1200" b="1" i="1" dirty="0" err="1" smtClean="0"/>
                <a:t>longistaminata</a:t>
              </a:r>
              <a:endParaRPr lang="en-IN" sz="1200" b="1" i="1" dirty="0"/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0" y="6410980"/>
            <a:ext cx="12601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Stemloop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structures of  conserved-miR394 (A) and  non-conserved-miR1866 (B) from 10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pecies.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1301447" y="0"/>
            <a:ext cx="642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mtClean="0"/>
              <a:t>B</a:t>
            </a:r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7316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</TotalTime>
  <Words>84</Words>
  <Application>Microsoft Office PowerPoint</Application>
  <PresentationFormat>Custom</PresentationFormat>
  <Paragraphs>2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kat</dc:creator>
  <cp:lastModifiedBy>Balindan, Danica Joy</cp:lastModifiedBy>
  <cp:revision>29</cp:revision>
  <dcterms:created xsi:type="dcterms:W3CDTF">2006-08-16T00:00:00Z</dcterms:created>
  <dcterms:modified xsi:type="dcterms:W3CDTF">2017-08-30T15:15:42Z</dcterms:modified>
</cp:coreProperties>
</file>